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2286000" cy="65516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E94325-71F2-4D82-B93C-3DCE1B7E317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71360" y="582480"/>
            <a:ext cx="1943280" cy="10922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71360" y="1893960"/>
            <a:ext cx="194328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71360" y="3947040"/>
            <a:ext cx="194328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74DDBE-B072-4052-A8EA-8BC1402951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71360" y="582480"/>
            <a:ext cx="1943280" cy="10922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71360" y="1893960"/>
            <a:ext cx="94824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167480" y="1893960"/>
            <a:ext cx="94824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71360" y="3947040"/>
            <a:ext cx="94824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167480" y="3947040"/>
            <a:ext cx="94824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0D6FF0-CD6E-4CA3-B846-83C21311CEA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71360" y="582480"/>
            <a:ext cx="1943280" cy="10922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71360" y="1893960"/>
            <a:ext cx="62532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828360" y="1893960"/>
            <a:ext cx="62532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485360" y="1893960"/>
            <a:ext cx="62532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71360" y="3947040"/>
            <a:ext cx="62532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828360" y="3947040"/>
            <a:ext cx="62532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485360" y="3947040"/>
            <a:ext cx="62532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773AEC-48EE-4EB7-B350-EDB9F25516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71360" y="582480"/>
            <a:ext cx="1943280" cy="10922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71360" y="1893960"/>
            <a:ext cx="1943280" cy="3930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4C630-5ADD-4E08-B7DE-1D2570F903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71360" y="582480"/>
            <a:ext cx="1943280" cy="10922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71360" y="1893960"/>
            <a:ext cx="1943280" cy="39304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AAAF70-7CCE-49E2-9A4B-418A776068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71360" y="582480"/>
            <a:ext cx="1943280" cy="10922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71360" y="1893960"/>
            <a:ext cx="948240" cy="39304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167480" y="1893960"/>
            <a:ext cx="948240" cy="39304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9409EF-74E9-4C2A-A3D1-0675C08481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71360" y="582480"/>
            <a:ext cx="1943280" cy="10922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122B29-02A7-492E-BB0E-AA1240BB8F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71360" y="582480"/>
            <a:ext cx="1943280" cy="5064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E1677A-39BC-4B72-AB39-8924D625BC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71360" y="582480"/>
            <a:ext cx="1943280" cy="10922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71360" y="1893960"/>
            <a:ext cx="94824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167480" y="1893960"/>
            <a:ext cx="948240" cy="39304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71360" y="3947040"/>
            <a:ext cx="94824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86361E-C71D-4844-9057-A0151A3B7C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71360" y="582480"/>
            <a:ext cx="1943280" cy="10922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71360" y="1893960"/>
            <a:ext cx="948240" cy="39304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167480" y="1893960"/>
            <a:ext cx="94824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167480" y="3947040"/>
            <a:ext cx="94824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CBFE76-BA82-436E-944E-420D62037F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71360" y="582480"/>
            <a:ext cx="1943280" cy="10922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71360" y="1893960"/>
            <a:ext cx="94824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167480" y="1893960"/>
            <a:ext cx="94824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71360" y="3947040"/>
            <a:ext cx="1943280" cy="187452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898657-EACA-4E86-8C41-F0E610BB9A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71360" y="582480"/>
            <a:ext cx="1943280" cy="10922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71360" y="1893960"/>
            <a:ext cx="1943280" cy="39304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 fontScale="79000"/>
          </a:bodyPr>
          <a:p>
            <a:pPr marL="149040" indent="-149040">
              <a:spcBef>
                <a:spcPts val="451"/>
              </a:spcBef>
              <a:buClr>
                <a:srgbClr val="000000"/>
              </a:buClr>
              <a:buFont typeface="Times New Roman"/>
              <a:buChar char="•"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1" marL="323640" indent="-124200">
              <a:spcBef>
                <a:spcPts val="451"/>
              </a:spcBef>
              <a:buClr>
                <a:srgbClr val="000000"/>
              </a:buClr>
              <a:buFont typeface="Times New Roman"/>
              <a:buChar char="–"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2" marL="498960" indent="-100080">
              <a:spcBef>
                <a:spcPts val="451"/>
              </a:spcBef>
              <a:buClr>
                <a:srgbClr val="000000"/>
              </a:buClr>
              <a:buFont typeface="Times New Roman"/>
              <a:buChar char="•"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3" marL="698400" indent="-100080">
              <a:spcBef>
                <a:spcPts val="451"/>
              </a:spcBef>
              <a:buClr>
                <a:srgbClr val="000000"/>
              </a:buClr>
              <a:buFont typeface="Times New Roman"/>
              <a:buChar char="–"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4" marL="897840" indent="-100080">
              <a:spcBef>
                <a:spcPts val="451"/>
              </a:spcBef>
              <a:buClr>
                <a:srgbClr val="000000"/>
              </a:buClr>
              <a:buFont typeface="Times New Roman"/>
              <a:buChar char="»"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5" marL="897840" indent="-100080">
              <a:spcBef>
                <a:spcPts val="451"/>
              </a:spcBef>
              <a:buClr>
                <a:srgbClr val="000000"/>
              </a:buClr>
              <a:buFont typeface="Times New Roman"/>
              <a:buChar char="»"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lvl="6" marL="897840" indent="-100080">
              <a:spcBef>
                <a:spcPts val="451"/>
              </a:spcBef>
              <a:buClr>
                <a:srgbClr val="000000"/>
              </a:buClr>
              <a:buFont typeface="Times New Roman"/>
              <a:buChar char="»"/>
              <a:tabLst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71000" y="5970240"/>
            <a:ext cx="476280" cy="4366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Autofit/>
          </a:bodyPr>
          <a:lstStyle>
            <a:lvl1pPr indent="0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  <a:defRPr b="0" lang="en-GB" sz="8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781200" y="5970240"/>
            <a:ext cx="723600" cy="4366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Autofit/>
          </a:bodyPr>
          <a:lstStyle>
            <a:lvl1pPr indent="0" algn="ct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  <a:defRPr b="0" lang="en-GB" sz="8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638000" y="5970240"/>
            <a:ext cx="476280" cy="4366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Autofit/>
          </a:bodyPr>
          <a:lstStyle>
            <a:lvl1pPr indent="0" algn="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  <a:defRPr b="0" lang="en-GB" sz="8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504720"/>
                <a:tab algn="l" pos="1009800"/>
                <a:tab algn="l" pos="1514520"/>
                <a:tab algn="l" pos="2019240"/>
                <a:tab algn="l" pos="2523960"/>
                <a:tab algn="l" pos="3029040"/>
                <a:tab algn="l" pos="3533760"/>
                <a:tab algn="l" pos="4038480"/>
                <a:tab algn="l" pos="4543560"/>
                <a:tab algn="l" pos="5048280"/>
                <a:tab algn="l" pos="5553000"/>
                <a:tab algn="l" pos="6058080"/>
                <a:tab algn="l" pos="6562800"/>
                <a:tab algn="l" pos="7067520"/>
                <a:tab algn="l" pos="7572240"/>
                <a:tab algn="l" pos="8077320"/>
                <a:tab algn="l" pos="8582040"/>
                <a:tab algn="l" pos="9086760"/>
                <a:tab algn="l" pos="9591840"/>
                <a:tab algn="l" pos="10096560"/>
              </a:tabLst>
            </a:pPr>
            <a:fld id="{2A5D5B50-DADB-42BE-B609-23163E321EA2}" type="slidenum"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3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6480" y="19080"/>
            <a:ext cx="2286000" cy="6534000"/>
            <a:chOff x="6480" y="19080"/>
            <a:chExt cx="2286000" cy="6534000"/>
          </a:xfrm>
        </p:grpSpPr>
        <p:graphicFrame>
          <p:nvGraphicFramePr>
            <p:cNvPr id="42" name=""/>
            <p:cNvGraphicFramePr/>
            <p:nvPr/>
          </p:nvGraphicFramePr>
          <p:xfrm>
            <a:off x="284040" y="19080"/>
            <a:ext cx="1573200" cy="140652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84040" y="19080"/>
                      <a:ext cx="1573200" cy="1406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"/>
            <p:cNvSpPr/>
            <p:nvPr/>
          </p:nvSpPr>
          <p:spPr>
            <a:xfrm>
              <a:off x="1101240" y="192240"/>
              <a:ext cx="718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S19 + HIV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aphicFrame>
          <p:nvGraphicFramePr>
            <p:cNvPr id="45" name=""/>
            <p:cNvGraphicFramePr/>
            <p:nvPr/>
          </p:nvGraphicFramePr>
          <p:xfrm>
            <a:off x="297000" y="1217880"/>
            <a:ext cx="1573200" cy="140652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46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297000" y="1217880"/>
                      <a:ext cx="1573200" cy="1406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7" name=""/>
            <p:cNvSpPr/>
            <p:nvPr/>
          </p:nvSpPr>
          <p:spPr>
            <a:xfrm>
              <a:off x="1127160" y="1387440"/>
              <a:ext cx="677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S19 + R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aphicFrame>
          <p:nvGraphicFramePr>
            <p:cNvPr id="48" name=""/>
            <p:cNvGraphicFramePr/>
            <p:nvPr/>
          </p:nvGraphicFramePr>
          <p:xfrm>
            <a:off x="297000" y="2433600"/>
            <a:ext cx="1573200" cy="1406520"/>
          </p:xfrm>
          <a:graphic>
            <a:graphicData uri="http://schemas.openxmlformats.org/presentationml/2006/ole">
              <p:oleObj progId="Excel.Sheet.12" r:id="rId5" spid="">
                <p:embed/>
                <p:pic>
                  <p:nvPicPr>
                    <p:cNvPr id="49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297000" y="2433600"/>
                      <a:ext cx="1573200" cy="1406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0" name=""/>
            <p:cNvSpPr/>
            <p:nvPr/>
          </p:nvSpPr>
          <p:spPr>
            <a:xfrm>
              <a:off x="1126440" y="2608200"/>
              <a:ext cx="59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R1 + HIV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891000" y="3764160"/>
              <a:ext cx="316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dpi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 rot="16200000">
              <a:off x="-212760" y="603360"/>
              <a:ext cx="1006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S19/(AS19+HIV)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 rot="16200000">
              <a:off x="-201600" y="1812240"/>
              <a:ext cx="965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S19/(AS19+R1)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 rot="16200000">
              <a:off x="-97200" y="3000240"/>
              <a:ext cx="766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R1/(R1+HIV)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 rot="21543600">
              <a:off x="495360" y="4032000"/>
              <a:ext cx="88920" cy="889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 rot="21543600">
              <a:off x="1203480" y="4039920"/>
              <a:ext cx="88920" cy="88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38920" y="396396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upT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252080" y="3963960"/>
              <a:ext cx="545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MC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6480" y="4268880"/>
              <a:ext cx="2286000" cy="228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Additional file 2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Graphic quantification of the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relative viral abundance in SupT1 and PBMC. The density of the PCR products from Figures 5 and 6 were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calculated with the ImageJ software by the formula: (density of variant band)/(combined densities of variant + HIV bands) after background intensities were subtracted in each case. 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06T13:12:57Z</dcterms:created>
  <dc:creator>Raymond Huismans</dc:creator>
  <dc:description/>
  <dc:language>en-US</dc:language>
  <cp:lastModifiedBy>Raymond Huismans</cp:lastModifiedBy>
  <dcterms:modified xsi:type="dcterms:W3CDTF">2007-02-26T11:15:48Z</dcterms:modified>
  <cp:revision>12</cp:revision>
  <dc:subject/>
  <dc:title>PowerPoint Presentation</dc:title>
</cp:coreProperties>
</file>